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9.jpeg" ContentType="image/jpe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51450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C826A-485B-42C5-B8E3-AAE0D66CAB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6172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2973240"/>
            <a:ext cx="6172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1849E2-0E31-4175-8EA3-9ED513B6DC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5D44C3-150B-49EA-A28D-05575F6AC0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200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200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2973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2973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2973240"/>
            <a:ext cx="1987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BFAF1-BD34-4AD4-80F5-2D6ADA3FBB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200240"/>
            <a:ext cx="6172200" cy="3394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D05BFC-6163-4DD7-B1F7-80ADE0A37F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61722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B48357-E5C5-4359-AAA0-52E3138E3D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2D1DEF-E770-4BC9-8D26-B5C60553D4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D5763-C2F7-4120-B39F-91D3361BEF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206280"/>
            <a:ext cx="6172200" cy="397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CA6C8-D865-4857-A269-DC8EA05327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A44882-0645-4F50-9139-3398E57201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2973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95E9AB-81A0-4C89-9BED-760DE1285A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200240"/>
            <a:ext cx="301176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2973240"/>
            <a:ext cx="61722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5B286-F8EC-4EB5-9EF0-0D603D3A02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206280"/>
            <a:ext cx="61722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200240"/>
            <a:ext cx="61722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5600" indent="-255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555480" indent="-2124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2" marL="855720" indent="-16992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3" marL="1198440" indent="-1695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4" marL="1541520" indent="-16992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5" marL="1541520" indent="-16992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6" marL="1541520" indent="-16992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684360"/>
                <a:tab algn="l" pos="1368360"/>
                <a:tab algn="l" pos="2052720"/>
                <a:tab algn="l" pos="2736720"/>
                <a:tab algn="l" pos="3421080"/>
                <a:tab algn="l" pos="4105440"/>
                <a:tab algn="l" pos="4789440"/>
                <a:tab algn="l" pos="5473800"/>
                <a:tab algn="l" pos="6157800"/>
                <a:tab algn="l" pos="6842160"/>
                <a:tab algn="l" pos="7526160"/>
                <a:tab algn="l" pos="8210520"/>
                <a:tab algn="l" pos="8894880"/>
                <a:tab algn="l" pos="9578880"/>
                <a:tab algn="l" pos="10263240"/>
                <a:tab algn="l" pos="1094724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4766760"/>
            <a:ext cx="160020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4766760"/>
            <a:ext cx="217152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4766760"/>
            <a:ext cx="160020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26CB8AE-0B30-4804-8F23-E18755BBFDDC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8" descr=""/>
          <p:cNvPicPr/>
          <p:nvPr/>
        </p:nvPicPr>
        <p:blipFill>
          <a:blip r:embed="rId1"/>
          <a:stretch/>
        </p:blipFill>
        <p:spPr>
          <a:xfrm>
            <a:off x="671400" y="696960"/>
            <a:ext cx="5310360" cy="3736800"/>
          </a:xfrm>
          <a:prstGeom prst="rect">
            <a:avLst/>
          </a:prstGeom>
          <a:ln w="0">
            <a:noFill/>
          </a:ln>
        </p:spPr>
      </p:pic>
      <p:sp>
        <p:nvSpPr>
          <p:cNvPr id="42" name="Left Brace 30"/>
          <p:cNvSpPr/>
          <p:nvPr/>
        </p:nvSpPr>
        <p:spPr>
          <a:xfrm rot="5400000">
            <a:off x="1259280" y="343440"/>
            <a:ext cx="49320" cy="1199880"/>
          </a:xfrm>
          <a:custGeom>
            <a:avLst/>
            <a:gdLst>
              <a:gd name="textAreaLeft" fmla="*/ 31680 w 49320"/>
              <a:gd name="textAreaRight" fmla="*/ 49680 w 49320"/>
              <a:gd name="textAreaTop" fmla="*/ 1080 h 1199880"/>
              <a:gd name="textAreaBottom" fmla="*/ 1198800 h 11998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7"/>
                  <a:pt x="10800" y="74"/>
                </a:cubicBezTo>
                <a:lnTo>
                  <a:pt x="10800" y="10726"/>
                </a:lnTo>
                <a:cubicBezTo>
                  <a:pt x="10800" y="10763"/>
                  <a:pt x="5400" y="10800"/>
                  <a:pt x="0" y="10800"/>
                </a:cubicBezTo>
                <a:cubicBezTo>
                  <a:pt x="5400" y="10800"/>
                  <a:pt x="10800" y="10837"/>
                  <a:pt x="10800" y="10874"/>
                </a:cubicBezTo>
                <a:lnTo>
                  <a:pt x="10800" y="21526"/>
                </a:lnTo>
                <a:cubicBezTo>
                  <a:pt x="10800" y="21563"/>
                  <a:pt x="16200" y="21600"/>
                  <a:pt x="21600" y="21600"/>
                </a:cubicBezTo>
              </a:path>
            </a:pathLst>
          </a:cu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Left Brace 31"/>
          <p:cNvSpPr/>
          <p:nvPr/>
        </p:nvSpPr>
        <p:spPr>
          <a:xfrm rot="5400000">
            <a:off x="2259360" y="600480"/>
            <a:ext cx="49320" cy="685800"/>
          </a:xfrm>
          <a:custGeom>
            <a:avLst/>
            <a:gdLst>
              <a:gd name="textAreaLeft" fmla="*/ 31680 w 49320"/>
              <a:gd name="textAreaRight" fmla="*/ 49680 w 49320"/>
              <a:gd name="textAreaTop" fmla="*/ 1080 h 685800"/>
              <a:gd name="textAreaBottom" fmla="*/ 684720 h 685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5"/>
                  <a:pt x="10800" y="129"/>
                </a:cubicBezTo>
                <a:lnTo>
                  <a:pt x="10800" y="10671"/>
                </a:lnTo>
                <a:cubicBezTo>
                  <a:pt x="10800" y="10736"/>
                  <a:pt x="5400" y="10800"/>
                  <a:pt x="0" y="10800"/>
                </a:cubicBezTo>
                <a:cubicBezTo>
                  <a:pt x="5400" y="10800"/>
                  <a:pt x="10800" y="10865"/>
                  <a:pt x="10800" y="10929"/>
                </a:cubicBezTo>
                <a:lnTo>
                  <a:pt x="10800" y="21471"/>
                </a:lnTo>
                <a:cubicBezTo>
                  <a:pt x="10800" y="21536"/>
                  <a:pt x="16200" y="21600"/>
                  <a:pt x="21600" y="21600"/>
                </a:cubicBezTo>
              </a:path>
            </a:pathLst>
          </a:cu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Left Brace 32"/>
          <p:cNvSpPr/>
          <p:nvPr/>
        </p:nvSpPr>
        <p:spPr>
          <a:xfrm rot="5400000">
            <a:off x="3310920" y="269640"/>
            <a:ext cx="44640" cy="1359000"/>
          </a:xfrm>
          <a:custGeom>
            <a:avLst/>
            <a:gdLst>
              <a:gd name="textAreaLeft" fmla="*/ 28440 w 44640"/>
              <a:gd name="textAreaRight" fmla="*/ 45000 w 44640"/>
              <a:gd name="textAreaTop" fmla="*/ 1080 h 1359000"/>
              <a:gd name="textAreaBottom" fmla="*/ 1357920 h 1359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0"/>
                  <a:pt x="10800" y="59"/>
                </a:cubicBezTo>
                <a:lnTo>
                  <a:pt x="10800" y="10741"/>
                </a:lnTo>
                <a:cubicBezTo>
                  <a:pt x="10800" y="10771"/>
                  <a:pt x="5400" y="10800"/>
                  <a:pt x="0" y="10800"/>
                </a:cubicBezTo>
                <a:cubicBezTo>
                  <a:pt x="5400" y="10800"/>
                  <a:pt x="10800" y="10830"/>
                  <a:pt x="10800" y="10859"/>
                </a:cubicBezTo>
                <a:lnTo>
                  <a:pt x="10800" y="21541"/>
                </a:lnTo>
                <a:cubicBezTo>
                  <a:pt x="10800" y="21571"/>
                  <a:pt x="16200" y="21600"/>
                  <a:pt x="21600" y="21600"/>
                </a:cubicBezTo>
              </a:path>
            </a:pathLst>
          </a:cu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Left Brace 33"/>
          <p:cNvSpPr/>
          <p:nvPr/>
        </p:nvSpPr>
        <p:spPr>
          <a:xfrm rot="5400000">
            <a:off x="4281840" y="693000"/>
            <a:ext cx="49320" cy="501480"/>
          </a:xfrm>
          <a:custGeom>
            <a:avLst/>
            <a:gdLst>
              <a:gd name="textAreaLeft" fmla="*/ 31680 w 49320"/>
              <a:gd name="textAreaRight" fmla="*/ 49680 w 49320"/>
              <a:gd name="textAreaTop" fmla="*/ 1080 h 501480"/>
              <a:gd name="textAreaBottom" fmla="*/ 500400 h 5014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89"/>
                  <a:pt x="10800" y="177"/>
                </a:cubicBezTo>
                <a:lnTo>
                  <a:pt x="10800" y="10623"/>
                </a:lnTo>
                <a:cubicBezTo>
                  <a:pt x="10800" y="10712"/>
                  <a:pt x="5400" y="10800"/>
                  <a:pt x="0" y="10800"/>
                </a:cubicBezTo>
                <a:cubicBezTo>
                  <a:pt x="5400" y="10800"/>
                  <a:pt x="10800" y="10889"/>
                  <a:pt x="10800" y="10977"/>
                </a:cubicBezTo>
                <a:lnTo>
                  <a:pt x="10800" y="21423"/>
                </a:lnTo>
                <a:cubicBezTo>
                  <a:pt x="10800" y="21512"/>
                  <a:pt x="16200" y="21600"/>
                  <a:pt x="21600" y="21600"/>
                </a:cubicBezTo>
              </a:path>
            </a:pathLst>
          </a:cu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Left Brace 34"/>
          <p:cNvSpPr/>
          <p:nvPr/>
        </p:nvSpPr>
        <p:spPr>
          <a:xfrm rot="5400000">
            <a:off x="4761000" y="765720"/>
            <a:ext cx="44640" cy="366840"/>
          </a:xfrm>
          <a:custGeom>
            <a:avLst/>
            <a:gdLst>
              <a:gd name="textAreaLeft" fmla="*/ 28440 w 44640"/>
              <a:gd name="textAreaRight" fmla="*/ 45000 w 44640"/>
              <a:gd name="textAreaTop" fmla="*/ 1080 h 366840"/>
              <a:gd name="textAreaBottom" fmla="*/ 365760 h 366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10"/>
                  <a:pt x="10800" y="220"/>
                </a:cubicBezTo>
                <a:lnTo>
                  <a:pt x="10800" y="10580"/>
                </a:lnTo>
                <a:cubicBezTo>
                  <a:pt x="10800" y="10690"/>
                  <a:pt x="5400" y="10800"/>
                  <a:pt x="0" y="10800"/>
                </a:cubicBezTo>
                <a:cubicBezTo>
                  <a:pt x="5400" y="10800"/>
                  <a:pt x="10800" y="10910"/>
                  <a:pt x="10800" y="11020"/>
                </a:cubicBezTo>
                <a:lnTo>
                  <a:pt x="10800" y="21380"/>
                </a:lnTo>
                <a:cubicBezTo>
                  <a:pt x="10800" y="21490"/>
                  <a:pt x="16200" y="21600"/>
                  <a:pt x="21600" y="21600"/>
                </a:cubicBezTo>
              </a:path>
            </a:pathLst>
          </a:cu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Left Brace 35"/>
          <p:cNvSpPr/>
          <p:nvPr/>
        </p:nvSpPr>
        <p:spPr>
          <a:xfrm rot="5400000">
            <a:off x="5500800" y="473760"/>
            <a:ext cx="36720" cy="942840"/>
          </a:xfrm>
          <a:custGeom>
            <a:avLst/>
            <a:gdLst>
              <a:gd name="textAreaLeft" fmla="*/ 23400 w 36720"/>
              <a:gd name="textAreaRight" fmla="*/ 37080 w 36720"/>
              <a:gd name="textAreaTop" fmla="*/ 720 h 942840"/>
              <a:gd name="textAreaBottom" fmla="*/ 942120 h 9428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6"/>
                  <a:pt x="10800" y="71"/>
                </a:cubicBezTo>
                <a:lnTo>
                  <a:pt x="10800" y="10729"/>
                </a:lnTo>
                <a:cubicBezTo>
                  <a:pt x="10800" y="10765"/>
                  <a:pt x="5400" y="10800"/>
                  <a:pt x="0" y="10800"/>
                </a:cubicBezTo>
                <a:cubicBezTo>
                  <a:pt x="5400" y="10800"/>
                  <a:pt x="10800" y="10836"/>
                  <a:pt x="10800" y="10871"/>
                </a:cubicBezTo>
                <a:lnTo>
                  <a:pt x="10800" y="21529"/>
                </a:lnTo>
                <a:cubicBezTo>
                  <a:pt x="10800" y="21565"/>
                  <a:pt x="16200" y="21600"/>
                  <a:pt x="21600" y="21600"/>
                </a:cubicBezTo>
              </a:path>
            </a:pathLst>
          </a:cu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780840" y="736560"/>
            <a:ext cx="1052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Adhesins/OMP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9"/>
          <p:cNvSpPr/>
          <p:nvPr/>
        </p:nvSpPr>
        <p:spPr>
          <a:xfrm>
            <a:off x="2008800" y="644400"/>
            <a:ext cx="55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SPI-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effector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0"/>
          <p:cNvSpPr/>
          <p:nvPr/>
        </p:nvSpPr>
        <p:spPr>
          <a:xfrm>
            <a:off x="3035880" y="638280"/>
            <a:ext cx="55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SPI-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effector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1"/>
          <p:cNvSpPr/>
          <p:nvPr/>
        </p:nvSpPr>
        <p:spPr>
          <a:xfrm>
            <a:off x="4025880" y="649440"/>
            <a:ext cx="56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SPI-1 &amp; 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effector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4462920" y="644400"/>
            <a:ext cx="700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independen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effector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3"/>
          <p:cNvSpPr/>
          <p:nvPr/>
        </p:nvSpPr>
        <p:spPr>
          <a:xfrm>
            <a:off x="5070240" y="646200"/>
            <a:ext cx="898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PhoPQ-regulated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enes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eft Brace 2"/>
          <p:cNvSpPr/>
          <p:nvPr/>
        </p:nvSpPr>
        <p:spPr>
          <a:xfrm>
            <a:off x="646200" y="1241280"/>
            <a:ext cx="33120" cy="481320"/>
          </a:xfrm>
          <a:custGeom>
            <a:avLst/>
            <a:gdLst>
              <a:gd name="textAreaLeft" fmla="*/ 21240 w 33120"/>
              <a:gd name="textAreaRight" fmla="*/ 33480 w 33120"/>
              <a:gd name="textAreaTop" fmla="*/ 720 h 481320"/>
              <a:gd name="textAreaBottom" fmla="*/ 480600 h 4813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4"/>
                  <a:pt x="10800" y="128"/>
                </a:cubicBezTo>
                <a:lnTo>
                  <a:pt x="10800" y="10672"/>
                </a:lnTo>
                <a:cubicBezTo>
                  <a:pt x="10800" y="10736"/>
                  <a:pt x="5400" y="10800"/>
                  <a:pt x="0" y="10800"/>
                </a:cubicBezTo>
                <a:cubicBezTo>
                  <a:pt x="5400" y="10800"/>
                  <a:pt x="10800" y="10864"/>
                  <a:pt x="10800" y="10928"/>
                </a:cubicBezTo>
                <a:lnTo>
                  <a:pt x="10800" y="21472"/>
                </a:lnTo>
                <a:cubicBezTo>
                  <a:pt x="10800" y="21536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eft Brace 3"/>
          <p:cNvSpPr/>
          <p:nvPr/>
        </p:nvSpPr>
        <p:spPr>
          <a:xfrm>
            <a:off x="636480" y="1727280"/>
            <a:ext cx="49320" cy="480960"/>
          </a:xfrm>
          <a:custGeom>
            <a:avLst/>
            <a:gdLst>
              <a:gd name="textAreaLeft" fmla="*/ 31680 w 49320"/>
              <a:gd name="textAreaRight" fmla="*/ 49680 w 49320"/>
              <a:gd name="textAreaTop" fmla="*/ 1080 h 480960"/>
              <a:gd name="textAreaBottom" fmla="*/ 479880 h 4809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3"/>
                  <a:pt x="10800" y="185"/>
                </a:cubicBezTo>
                <a:lnTo>
                  <a:pt x="10800" y="10615"/>
                </a:lnTo>
                <a:cubicBezTo>
                  <a:pt x="10800" y="10708"/>
                  <a:pt x="5400" y="10800"/>
                  <a:pt x="0" y="10800"/>
                </a:cubicBezTo>
                <a:cubicBezTo>
                  <a:pt x="5400" y="10800"/>
                  <a:pt x="10800" y="10893"/>
                  <a:pt x="10800" y="10985"/>
                </a:cubicBezTo>
                <a:lnTo>
                  <a:pt x="10800" y="21415"/>
                </a:lnTo>
                <a:cubicBezTo>
                  <a:pt x="10800" y="21508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Left Brace 4"/>
          <p:cNvSpPr/>
          <p:nvPr/>
        </p:nvSpPr>
        <p:spPr>
          <a:xfrm>
            <a:off x="647640" y="2206800"/>
            <a:ext cx="33480" cy="473040"/>
          </a:xfrm>
          <a:custGeom>
            <a:avLst/>
            <a:gdLst>
              <a:gd name="textAreaLeft" fmla="*/ 21600 w 33480"/>
              <a:gd name="textAreaRight" fmla="*/ 33840 w 33480"/>
              <a:gd name="textAreaTop" fmla="*/ 720 h 473040"/>
              <a:gd name="textAreaBottom" fmla="*/ 472320 h 473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6"/>
                  <a:pt x="10800" y="131"/>
                </a:cubicBezTo>
                <a:lnTo>
                  <a:pt x="10800" y="10669"/>
                </a:lnTo>
                <a:cubicBezTo>
                  <a:pt x="10800" y="10735"/>
                  <a:pt x="5400" y="10800"/>
                  <a:pt x="0" y="10800"/>
                </a:cubicBezTo>
                <a:cubicBezTo>
                  <a:pt x="5400" y="10800"/>
                  <a:pt x="10800" y="10866"/>
                  <a:pt x="10800" y="10931"/>
                </a:cubicBezTo>
                <a:lnTo>
                  <a:pt x="10800" y="21469"/>
                </a:lnTo>
                <a:cubicBezTo>
                  <a:pt x="10800" y="21535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eft Brace 5"/>
          <p:cNvSpPr/>
          <p:nvPr/>
        </p:nvSpPr>
        <p:spPr>
          <a:xfrm>
            <a:off x="642960" y="2679840"/>
            <a:ext cx="34920" cy="468000"/>
          </a:xfrm>
          <a:custGeom>
            <a:avLst/>
            <a:gdLst>
              <a:gd name="textAreaLeft" fmla="*/ 22320 w 34920"/>
              <a:gd name="textAreaRight" fmla="*/ 35280 w 34920"/>
              <a:gd name="textAreaTop" fmla="*/ 720 h 468000"/>
              <a:gd name="textAreaBottom" fmla="*/ 467280 h 468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6"/>
                  <a:pt x="10800" y="132"/>
                </a:cubicBezTo>
                <a:lnTo>
                  <a:pt x="10800" y="10668"/>
                </a:lnTo>
                <a:cubicBezTo>
                  <a:pt x="10800" y="10734"/>
                  <a:pt x="5400" y="10800"/>
                  <a:pt x="0" y="10800"/>
                </a:cubicBezTo>
                <a:cubicBezTo>
                  <a:pt x="5400" y="10800"/>
                  <a:pt x="10800" y="10866"/>
                  <a:pt x="10800" y="10932"/>
                </a:cubicBezTo>
                <a:lnTo>
                  <a:pt x="10800" y="21468"/>
                </a:lnTo>
                <a:cubicBezTo>
                  <a:pt x="10800" y="21534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Left Brace 6"/>
          <p:cNvSpPr/>
          <p:nvPr/>
        </p:nvSpPr>
        <p:spPr>
          <a:xfrm>
            <a:off x="647640" y="3954600"/>
            <a:ext cx="33480" cy="492120"/>
          </a:xfrm>
          <a:custGeom>
            <a:avLst/>
            <a:gdLst>
              <a:gd name="textAreaLeft" fmla="*/ 21600 w 33480"/>
              <a:gd name="textAreaRight" fmla="*/ 33840 w 33480"/>
              <a:gd name="textAreaTop" fmla="*/ 720 h 492120"/>
              <a:gd name="textAreaBottom" fmla="*/ 491400 h 4921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3"/>
                  <a:pt x="10800" y="126"/>
                </a:cubicBezTo>
                <a:lnTo>
                  <a:pt x="10800" y="10674"/>
                </a:lnTo>
                <a:cubicBezTo>
                  <a:pt x="10800" y="10737"/>
                  <a:pt x="5400" y="10800"/>
                  <a:pt x="0" y="10800"/>
                </a:cubicBezTo>
                <a:cubicBezTo>
                  <a:pt x="5400" y="10800"/>
                  <a:pt x="10800" y="10863"/>
                  <a:pt x="10800" y="10926"/>
                </a:cubicBezTo>
                <a:lnTo>
                  <a:pt x="10800" y="21474"/>
                </a:lnTo>
                <a:cubicBezTo>
                  <a:pt x="10800" y="21537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eft Brace 7"/>
          <p:cNvSpPr/>
          <p:nvPr/>
        </p:nvSpPr>
        <p:spPr>
          <a:xfrm>
            <a:off x="644400" y="3494160"/>
            <a:ext cx="33480" cy="461880"/>
          </a:xfrm>
          <a:custGeom>
            <a:avLst/>
            <a:gdLst>
              <a:gd name="textAreaLeft" fmla="*/ 21600 w 33480"/>
              <a:gd name="textAreaRight" fmla="*/ 33840 w 33480"/>
              <a:gd name="textAreaTop" fmla="*/ 720 h 461880"/>
              <a:gd name="textAreaBottom" fmla="*/ 461160 h 4618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7"/>
                  <a:pt x="10800" y="134"/>
                </a:cubicBezTo>
                <a:lnTo>
                  <a:pt x="10800" y="10666"/>
                </a:lnTo>
                <a:cubicBezTo>
                  <a:pt x="10800" y="10733"/>
                  <a:pt x="5400" y="10800"/>
                  <a:pt x="0" y="10800"/>
                </a:cubicBezTo>
                <a:cubicBezTo>
                  <a:pt x="5400" y="10800"/>
                  <a:pt x="10800" y="10867"/>
                  <a:pt x="10800" y="10934"/>
                </a:cubicBezTo>
                <a:lnTo>
                  <a:pt x="10800" y="21466"/>
                </a:lnTo>
                <a:cubicBezTo>
                  <a:pt x="10800" y="21533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Left Brace 8"/>
          <p:cNvSpPr/>
          <p:nvPr/>
        </p:nvSpPr>
        <p:spPr>
          <a:xfrm>
            <a:off x="644400" y="3152880"/>
            <a:ext cx="34920" cy="347400"/>
          </a:xfrm>
          <a:custGeom>
            <a:avLst/>
            <a:gdLst>
              <a:gd name="textAreaLeft" fmla="*/ 22320 w 34920"/>
              <a:gd name="textAreaRight" fmla="*/ 35280 w 34920"/>
              <a:gd name="textAreaTop" fmla="*/ 720 h 347400"/>
              <a:gd name="textAreaBottom" fmla="*/ 346680 h 3474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4"/>
                  <a:pt x="10800" y="187"/>
                </a:cubicBezTo>
                <a:lnTo>
                  <a:pt x="10800" y="10613"/>
                </a:lnTo>
                <a:cubicBezTo>
                  <a:pt x="10800" y="10707"/>
                  <a:pt x="5400" y="10800"/>
                  <a:pt x="0" y="10800"/>
                </a:cubicBezTo>
                <a:cubicBezTo>
                  <a:pt x="5400" y="10800"/>
                  <a:pt x="10800" y="10894"/>
                  <a:pt x="10800" y="10987"/>
                </a:cubicBezTo>
                <a:lnTo>
                  <a:pt x="10800" y="21413"/>
                </a:lnTo>
                <a:cubicBezTo>
                  <a:pt x="10800" y="21507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TextBox 21" descr=""/>
          <p:cNvPicPr/>
          <p:nvPr/>
        </p:nvPicPr>
        <p:blipFill>
          <a:blip r:embed="rId2"/>
          <a:stretch/>
        </p:blipFill>
        <p:spPr>
          <a:xfrm>
            <a:off x="396720" y="1243080"/>
            <a:ext cx="273240" cy="482400"/>
          </a:xfrm>
          <a:prstGeom prst="rect">
            <a:avLst/>
          </a:prstGeom>
          <a:ln w="0">
            <a:noFill/>
          </a:ln>
        </p:spPr>
      </p:pic>
      <p:pic>
        <p:nvPicPr>
          <p:cNvPr id="62" name="TextBox 22" descr=""/>
          <p:cNvPicPr/>
          <p:nvPr/>
        </p:nvPicPr>
        <p:blipFill>
          <a:blip r:embed="rId3"/>
          <a:stretch/>
        </p:blipFill>
        <p:spPr>
          <a:xfrm>
            <a:off x="414360" y="1700280"/>
            <a:ext cx="274680" cy="536400"/>
          </a:xfrm>
          <a:prstGeom prst="rect">
            <a:avLst/>
          </a:prstGeom>
          <a:ln w="0">
            <a:noFill/>
          </a:ln>
        </p:spPr>
      </p:pic>
      <p:pic>
        <p:nvPicPr>
          <p:cNvPr id="63" name="TextBox 23" descr=""/>
          <p:cNvPicPr/>
          <p:nvPr/>
        </p:nvPicPr>
        <p:blipFill>
          <a:blip r:embed="rId4"/>
          <a:stretch/>
        </p:blipFill>
        <p:spPr>
          <a:xfrm>
            <a:off x="414360" y="2157480"/>
            <a:ext cx="324000" cy="579240"/>
          </a:xfrm>
          <a:prstGeom prst="rect">
            <a:avLst/>
          </a:prstGeom>
          <a:ln w="0">
            <a:noFill/>
          </a:ln>
        </p:spPr>
      </p:pic>
      <p:pic>
        <p:nvPicPr>
          <p:cNvPr id="64" name="TextBox 24" descr=""/>
          <p:cNvPicPr/>
          <p:nvPr/>
        </p:nvPicPr>
        <p:blipFill>
          <a:blip r:embed="rId5"/>
          <a:stretch/>
        </p:blipFill>
        <p:spPr>
          <a:xfrm>
            <a:off x="414360" y="2620800"/>
            <a:ext cx="274680" cy="579600"/>
          </a:xfrm>
          <a:prstGeom prst="rect">
            <a:avLst/>
          </a:prstGeom>
          <a:ln w="0">
            <a:noFill/>
          </a:ln>
        </p:spPr>
      </p:pic>
      <p:pic>
        <p:nvPicPr>
          <p:cNvPr id="65" name="TextBox 25" descr=""/>
          <p:cNvPicPr/>
          <p:nvPr/>
        </p:nvPicPr>
        <p:blipFill>
          <a:blip r:embed="rId6"/>
          <a:stretch/>
        </p:blipFill>
        <p:spPr>
          <a:xfrm>
            <a:off x="420840" y="3097080"/>
            <a:ext cx="280800" cy="474840"/>
          </a:xfrm>
          <a:prstGeom prst="rect">
            <a:avLst/>
          </a:prstGeom>
          <a:ln w="0">
            <a:noFill/>
          </a:ln>
        </p:spPr>
      </p:pic>
      <p:pic>
        <p:nvPicPr>
          <p:cNvPr id="66" name="TextBox 26" descr=""/>
          <p:cNvPicPr/>
          <p:nvPr/>
        </p:nvPicPr>
        <p:blipFill>
          <a:blip r:embed="rId7"/>
          <a:stretch/>
        </p:blipFill>
        <p:spPr>
          <a:xfrm>
            <a:off x="420840" y="3468600"/>
            <a:ext cx="280800" cy="560520"/>
          </a:xfrm>
          <a:prstGeom prst="rect">
            <a:avLst/>
          </a:prstGeom>
          <a:ln w="0">
            <a:noFill/>
          </a:ln>
        </p:spPr>
      </p:pic>
      <p:pic>
        <p:nvPicPr>
          <p:cNvPr id="67" name="TextBox 27" descr=""/>
          <p:cNvPicPr/>
          <p:nvPr/>
        </p:nvPicPr>
        <p:blipFill>
          <a:blip r:embed="rId8"/>
          <a:stretch/>
        </p:blipFill>
        <p:spPr>
          <a:xfrm>
            <a:off x="420840" y="3932280"/>
            <a:ext cx="274320" cy="554040"/>
          </a:xfrm>
          <a:prstGeom prst="rect">
            <a:avLst/>
          </a:prstGeom>
          <a:ln w="0">
            <a:noFill/>
          </a:ln>
        </p:spPr>
      </p:pic>
      <p:sp>
        <p:nvSpPr>
          <p:cNvPr id="68" name="TextBox 29"/>
          <p:cNvSpPr/>
          <p:nvPr/>
        </p:nvSpPr>
        <p:spPr>
          <a:xfrm>
            <a:off x="6481800" y="4000680"/>
            <a:ext cx="185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244080" y="209520"/>
            <a:ext cx="57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. S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Picture 33" descr=""/>
          <p:cNvPicPr/>
          <p:nvPr/>
        </p:nvPicPr>
        <p:blipFill>
          <a:blip r:embed="rId9"/>
          <a:srcRect l="0" t="0" r="68899" b="93539"/>
          <a:stretch/>
        </p:blipFill>
        <p:spPr>
          <a:xfrm>
            <a:off x="5048280" y="4481640"/>
            <a:ext cx="993600" cy="117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1-03T14:37:30Z</dcterms:created>
  <dc:creator>Thomas Kaufmann</dc:creator>
  <dc:description/>
  <dc:language>en-US</dc:language>
  <cp:lastModifiedBy>Alexey Rakov</cp:lastModifiedBy>
  <cp:lastPrinted>2018-10-15T22:13:39Z</cp:lastPrinted>
  <dcterms:modified xsi:type="dcterms:W3CDTF">2019-03-06T15:30:55Z</dcterms:modified>
  <cp:revision>233</cp:revision>
  <dc:subject/>
  <dc:title>PowerPoint Presentation</dc:title>
</cp:coreProperties>
</file>